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514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62A34C-7DA9-466C-A9B0-952F773E814A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F5971A-900C-41D0-8C26-4DFDC4CE53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667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F5971A-900C-41D0-8C26-4DFDC4CE53A5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671013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20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>
            <a:extLst>
              <a:ext uri="{FF2B5EF4-FFF2-40B4-BE49-F238E27FC236}">
                <a16:creationId xmlns:a16="http://schemas.microsoft.com/office/drawing/2014/main" id="{79FC735F-DE79-FD98-64E1-A829622D82BD}"/>
              </a:ext>
            </a:extLst>
          </p:cNvPr>
          <p:cNvGrpSpPr/>
          <p:nvPr/>
        </p:nvGrpSpPr>
        <p:grpSpPr>
          <a:xfrm>
            <a:off x="154259" y="115682"/>
            <a:ext cx="6523463" cy="8770504"/>
            <a:chOff x="86019" y="88386"/>
            <a:chExt cx="6523463" cy="8770504"/>
          </a:xfrm>
        </p:grpSpPr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B94B4076-0201-C249-058B-3D821DE45753}"/>
                </a:ext>
              </a:extLst>
            </p:cNvPr>
            <p:cNvSpPr txBox="1"/>
            <p:nvPr/>
          </p:nvSpPr>
          <p:spPr>
            <a:xfrm>
              <a:off x="309880" y="88386"/>
              <a:ext cx="6236971" cy="613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s-E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gure 2.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ting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tegy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z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y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metry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ion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haustion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nd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nescenc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er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CD4+ T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BMC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ticipants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  <p:pic>
          <p:nvPicPr>
            <p:cNvPr id="4" name="Imagen 3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42BD2A93-E890-B64E-DA5C-7D8DC6F7C4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8" t="-1" r="71616" b="77533"/>
            <a:stretch/>
          </p:blipFill>
          <p:spPr>
            <a:xfrm>
              <a:off x="140260" y="694496"/>
              <a:ext cx="1971340" cy="1864431"/>
            </a:xfrm>
            <a:prstGeom prst="rect">
              <a:avLst/>
            </a:prstGeom>
          </p:spPr>
        </p:pic>
        <p:pic>
          <p:nvPicPr>
            <p:cNvPr id="5" name="Imagen 4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07EB8849-F40C-217C-F022-96D328417B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88" t="257" r="34167" b="76495"/>
            <a:stretch/>
          </p:blipFill>
          <p:spPr>
            <a:xfrm>
              <a:off x="2282042" y="681322"/>
              <a:ext cx="2150459" cy="1952357"/>
            </a:xfrm>
            <a:prstGeom prst="rect">
              <a:avLst/>
            </a:prstGeom>
          </p:spPr>
        </p:pic>
        <p:pic>
          <p:nvPicPr>
            <p:cNvPr id="7" name="Imagen 6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2C249558-6ACF-4B8A-453A-E1428956D9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268" t="327" r="-1013" b="76425"/>
            <a:stretch/>
          </p:blipFill>
          <p:spPr>
            <a:xfrm>
              <a:off x="4459023" y="667869"/>
              <a:ext cx="2150459" cy="1952357"/>
            </a:xfrm>
            <a:prstGeom prst="rect">
              <a:avLst/>
            </a:prstGeom>
          </p:spPr>
        </p:pic>
        <p:pic>
          <p:nvPicPr>
            <p:cNvPr id="10" name="Imagen 9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1B18CD53-B737-F423-D023-D4677C59B8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39" t="24379" r="35645" b="52373"/>
            <a:stretch/>
          </p:blipFill>
          <p:spPr>
            <a:xfrm>
              <a:off x="2270150" y="2752036"/>
              <a:ext cx="2066008" cy="1952357"/>
            </a:xfrm>
            <a:prstGeom prst="rect">
              <a:avLst/>
            </a:prstGeom>
          </p:spPr>
        </p:pic>
        <p:pic>
          <p:nvPicPr>
            <p:cNvPr id="11" name="Imagen 10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36AFA3C5-67FB-622F-81FC-7499C232D8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384" t="23859" b="52893"/>
            <a:stretch/>
          </p:blipFill>
          <p:spPr>
            <a:xfrm>
              <a:off x="133165" y="4858397"/>
              <a:ext cx="2066008" cy="1952357"/>
            </a:xfrm>
            <a:prstGeom prst="rect">
              <a:avLst/>
            </a:prstGeom>
          </p:spPr>
        </p:pic>
        <p:pic>
          <p:nvPicPr>
            <p:cNvPr id="12" name="Imagen 11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47423877-B879-BD31-EF91-F993FCCEB8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476" r="72384" b="25276"/>
            <a:stretch/>
          </p:blipFill>
          <p:spPr>
            <a:xfrm>
              <a:off x="4419224" y="2763009"/>
              <a:ext cx="2066008" cy="1952357"/>
            </a:xfrm>
            <a:prstGeom prst="rect">
              <a:avLst/>
            </a:prstGeom>
          </p:spPr>
        </p:pic>
        <p:pic>
          <p:nvPicPr>
            <p:cNvPr id="13" name="Imagen 12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04C2FFCC-4D22-A91B-6B91-A439FDA008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50" t="50448" r="34369" b="25048"/>
            <a:stretch/>
          </p:blipFill>
          <p:spPr>
            <a:xfrm>
              <a:off x="2376306" y="4873437"/>
              <a:ext cx="1928642" cy="1882566"/>
            </a:xfrm>
            <a:prstGeom prst="rect">
              <a:avLst/>
            </a:prstGeom>
          </p:spPr>
        </p:pic>
        <p:pic>
          <p:nvPicPr>
            <p:cNvPr id="14" name="Imagen 13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65399DA3-0AB1-6643-D0C3-ED884B0E4C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384" t="51476" b="25276"/>
            <a:stretch/>
          </p:blipFill>
          <p:spPr>
            <a:xfrm>
              <a:off x="4450777" y="4862024"/>
              <a:ext cx="2066008" cy="1952357"/>
            </a:xfrm>
            <a:prstGeom prst="rect">
              <a:avLst/>
            </a:prstGeom>
          </p:spPr>
        </p:pic>
        <p:pic>
          <p:nvPicPr>
            <p:cNvPr id="15" name="Imagen 14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D50C5A88-0ACD-D787-C0C5-38734552E7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027" r="72384" b="1725"/>
            <a:stretch/>
          </p:blipFill>
          <p:spPr>
            <a:xfrm>
              <a:off x="86019" y="6835846"/>
              <a:ext cx="2066008" cy="1952357"/>
            </a:xfrm>
            <a:prstGeom prst="rect">
              <a:avLst/>
            </a:prstGeom>
          </p:spPr>
        </p:pic>
        <p:pic>
          <p:nvPicPr>
            <p:cNvPr id="16" name="Imagen 15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359BBDC2-C66A-85E9-AAAF-DDA02DF242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47" t="74502" r="34372" b="994"/>
            <a:stretch/>
          </p:blipFill>
          <p:spPr>
            <a:xfrm>
              <a:off x="2278183" y="6733971"/>
              <a:ext cx="2108234" cy="2057868"/>
            </a:xfrm>
            <a:prstGeom prst="rect">
              <a:avLst/>
            </a:prstGeom>
          </p:spPr>
        </p:pic>
        <p:pic>
          <p:nvPicPr>
            <p:cNvPr id="17" name="Imagen 16" descr="Imagen que contiene Interfaz de usuario gráfica&#10;&#10;Descripción generada automáticamente">
              <a:extLst>
                <a:ext uri="{FF2B5EF4-FFF2-40B4-BE49-F238E27FC236}">
                  <a16:creationId xmlns:a16="http://schemas.microsoft.com/office/drawing/2014/main" id="{6076738D-9325-2EC9-A5EA-01AB407512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636" t="75626" r="-252" b="1126"/>
            <a:stretch/>
          </p:blipFill>
          <p:spPr>
            <a:xfrm>
              <a:off x="4487193" y="6906533"/>
              <a:ext cx="2066008" cy="1952357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48BCF48D-A4DC-404E-9099-FA1475CAD3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1" t="23851" r="69875" b="52777"/>
            <a:stretch/>
          </p:blipFill>
          <p:spPr>
            <a:xfrm>
              <a:off x="167488" y="2718009"/>
              <a:ext cx="2149746" cy="1993447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A5ADB239-A31D-4479-3E80-1AD0716EB0D5}"/>
                </a:ext>
              </a:extLst>
            </p:cNvPr>
            <p:cNvSpPr txBox="1"/>
            <p:nvPr/>
          </p:nvSpPr>
          <p:spPr>
            <a:xfrm>
              <a:off x="3542376" y="3894142"/>
              <a:ext cx="7553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(CD3+CD8-)</a:t>
              </a:r>
            </a:p>
          </p:txBody>
        </p:sp>
        <p:cxnSp>
          <p:nvCxnSpPr>
            <p:cNvPr id="9" name="Conector recto de flecha 8">
              <a:extLst>
                <a:ext uri="{FF2B5EF4-FFF2-40B4-BE49-F238E27FC236}">
                  <a16:creationId xmlns:a16="http://schemas.microsoft.com/office/drawing/2014/main" id="{B0DE8C24-914F-32FC-F7FB-1BAA23F8EF6D}"/>
                </a:ext>
              </a:extLst>
            </p:cNvPr>
            <p:cNvCxnSpPr/>
            <p:nvPr/>
          </p:nvCxnSpPr>
          <p:spPr>
            <a:xfrm>
              <a:off x="4275786" y="4230710"/>
              <a:ext cx="46363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de flecha 17">
              <a:extLst>
                <a:ext uri="{FF2B5EF4-FFF2-40B4-BE49-F238E27FC236}">
                  <a16:creationId xmlns:a16="http://schemas.microsoft.com/office/drawing/2014/main" id="{E9B35046-1744-F92D-2AC1-FAF6E5236A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70090" y="4411014"/>
              <a:ext cx="1481071" cy="39924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ector recto de flecha 19">
              <a:extLst>
                <a:ext uri="{FF2B5EF4-FFF2-40B4-BE49-F238E27FC236}">
                  <a16:creationId xmlns:a16="http://schemas.microsoft.com/office/drawing/2014/main" id="{E7F8E93E-3513-CB9F-8B77-A425CD7872B5}"/>
                </a:ext>
              </a:extLst>
            </p:cNvPr>
            <p:cNvCxnSpPr>
              <a:cxnSpLocks/>
            </p:cNvCxnSpPr>
            <p:nvPr/>
          </p:nvCxnSpPr>
          <p:spPr>
            <a:xfrm>
              <a:off x="3889420" y="4501166"/>
              <a:ext cx="0" cy="59243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ector recto de flecha 21">
              <a:extLst>
                <a:ext uri="{FF2B5EF4-FFF2-40B4-BE49-F238E27FC236}">
                  <a16:creationId xmlns:a16="http://schemas.microsoft.com/office/drawing/2014/main" id="{9E03ED26-DAA2-4879-AE16-48AF4540406D}"/>
                </a:ext>
              </a:extLst>
            </p:cNvPr>
            <p:cNvCxnSpPr>
              <a:cxnSpLocks/>
            </p:cNvCxnSpPr>
            <p:nvPr/>
          </p:nvCxnSpPr>
          <p:spPr>
            <a:xfrm>
              <a:off x="4127679" y="4489575"/>
              <a:ext cx="566671" cy="34000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878798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3</TotalTime>
  <Words>36</Words>
  <Application>Microsoft Office PowerPoint</Application>
  <PresentationFormat>Presentación en pantalla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ayte Coiras</cp:lastModifiedBy>
  <cp:revision>55</cp:revision>
  <dcterms:created xsi:type="dcterms:W3CDTF">2022-01-10T11:03:11Z</dcterms:created>
  <dcterms:modified xsi:type="dcterms:W3CDTF">2025-04-20T16:13:33Z</dcterms:modified>
</cp:coreProperties>
</file>